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2025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258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F230-868C-4945-9BB8-0F65C0EDDD19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E985D-29B9-4329-AE76-3A9892FFBD4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64687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F230-868C-4945-9BB8-0F65C0EDDD19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E985D-29B9-4329-AE76-3A9892FFBD4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03183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F230-868C-4945-9BB8-0F65C0EDDD19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E985D-29B9-4329-AE76-3A9892FFBD4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32767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F230-868C-4945-9BB8-0F65C0EDDD19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E985D-29B9-4329-AE76-3A9892FFBD4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317840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F230-868C-4945-9BB8-0F65C0EDDD19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E985D-29B9-4329-AE76-3A9892FFBD4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46659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F230-868C-4945-9BB8-0F65C0EDDD19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E985D-29B9-4329-AE76-3A9892FFBD4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128200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F230-868C-4945-9BB8-0F65C0EDDD19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E985D-29B9-4329-AE76-3A9892FFBD4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53339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F230-868C-4945-9BB8-0F65C0EDDD19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E985D-29B9-4329-AE76-3A9892FFBD4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786790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F230-868C-4945-9BB8-0F65C0EDDD19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E985D-29B9-4329-AE76-3A9892FFBD4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676396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F230-868C-4945-9BB8-0F65C0EDDD19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E985D-29B9-4329-AE76-3A9892FFBD4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758881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DF230-868C-4945-9BB8-0F65C0EDDD19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E985D-29B9-4329-AE76-3A9892FFBD4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968717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3DF230-868C-4945-9BB8-0F65C0EDDD19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9E985D-29B9-4329-AE76-3A9892FFBD4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191733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r" defTabSz="914400" rtl="1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r" defTabSz="914400" rtl="1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-up of a test strip&#10;&#10;Description automatically generated">
            <a:extLst>
              <a:ext uri="{FF2B5EF4-FFF2-40B4-BE49-F238E27FC236}">
                <a16:creationId xmlns="" xmlns:a16="http://schemas.microsoft.com/office/drawing/2014/main" id="{39673C16-1A9F-D545-8841-C1CD93A5E3D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8801" y="4543530"/>
            <a:ext cx="4137067" cy="2010740"/>
          </a:xfrm>
          <a:prstGeom prst="rect">
            <a:avLst/>
          </a:prstGeom>
        </p:spPr>
      </p:pic>
      <p:pic>
        <p:nvPicPr>
          <p:cNvPr id="6" name="Picture 5" descr="A white paper with black ink&#10;&#10;Description automatically generated">
            <a:extLst>
              <a:ext uri="{FF2B5EF4-FFF2-40B4-BE49-F238E27FC236}">
                <a16:creationId xmlns="" xmlns:a16="http://schemas.microsoft.com/office/drawing/2014/main" id="{71ED8B51-DA87-A211-A886-A1EFDA690CA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7866" y="286322"/>
            <a:ext cx="4137067" cy="1838875"/>
          </a:xfrm>
          <a:prstGeom prst="rect">
            <a:avLst/>
          </a:prstGeom>
        </p:spPr>
      </p:pic>
      <p:pic>
        <p:nvPicPr>
          <p:cNvPr id="8" name="Picture 7" descr="A close-up of a test strip&#10;&#10;Description automatically generated">
            <a:extLst>
              <a:ext uri="{FF2B5EF4-FFF2-40B4-BE49-F238E27FC236}">
                <a16:creationId xmlns="" xmlns:a16="http://schemas.microsoft.com/office/drawing/2014/main" id="{D6B037C3-38BF-309C-9E9D-A8CE4AF0BF0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0998" y="4543531"/>
            <a:ext cx="4137067" cy="2010739"/>
          </a:xfrm>
          <a:prstGeom prst="rect">
            <a:avLst/>
          </a:prstGeom>
        </p:spPr>
      </p:pic>
      <p:pic>
        <p:nvPicPr>
          <p:cNvPr id="12" name="Picture 11" descr="A white background with black dots&#10;&#10;Description automatically generated">
            <a:extLst>
              <a:ext uri="{FF2B5EF4-FFF2-40B4-BE49-F238E27FC236}">
                <a16:creationId xmlns="" xmlns:a16="http://schemas.microsoft.com/office/drawing/2014/main" id="{4A153444-5C07-AA74-4F9C-D8EBC7C72EA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7847" y="2115127"/>
            <a:ext cx="4137067" cy="2383435"/>
          </a:xfrm>
          <a:prstGeom prst="rect">
            <a:avLst/>
          </a:prstGeom>
        </p:spPr>
      </p:pic>
      <p:sp>
        <p:nvSpPr>
          <p:cNvPr id="15" name="Right Bracket 14">
            <a:extLst>
              <a:ext uri="{FF2B5EF4-FFF2-40B4-BE49-F238E27FC236}">
                <a16:creationId xmlns="" xmlns:a16="http://schemas.microsoft.com/office/drawing/2014/main" id="{9A543688-59F3-CFA0-6655-B9EEA11A4107}"/>
              </a:ext>
            </a:extLst>
          </p:cNvPr>
          <p:cNvSpPr/>
          <p:nvPr/>
        </p:nvSpPr>
        <p:spPr>
          <a:xfrm rot="5400000">
            <a:off x="3660654" y="5161184"/>
            <a:ext cx="150874" cy="86235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ight Bracket 15">
            <a:extLst>
              <a:ext uri="{FF2B5EF4-FFF2-40B4-BE49-F238E27FC236}">
                <a16:creationId xmlns="" xmlns:a16="http://schemas.microsoft.com/office/drawing/2014/main" id="{36BC6680-5538-2D47-B226-E0EF4DB7047B}"/>
              </a:ext>
            </a:extLst>
          </p:cNvPr>
          <p:cNvSpPr/>
          <p:nvPr/>
        </p:nvSpPr>
        <p:spPr>
          <a:xfrm rot="5400000">
            <a:off x="8894720" y="5223644"/>
            <a:ext cx="150874" cy="86235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0506CBD1-5A03-2354-6E4B-B61D23047D56}"/>
              </a:ext>
            </a:extLst>
          </p:cNvPr>
          <p:cNvSpPr txBox="1"/>
          <p:nvPr/>
        </p:nvSpPr>
        <p:spPr>
          <a:xfrm>
            <a:off x="10552300" y="5377593"/>
            <a:ext cx="774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1</a:t>
            </a:r>
          </a:p>
        </p:txBody>
      </p:sp>
      <p:pic>
        <p:nvPicPr>
          <p:cNvPr id="18" name="Picture 17" descr="A white background with black dots&#10;&#10;Description automatically generated">
            <a:extLst>
              <a:ext uri="{FF2B5EF4-FFF2-40B4-BE49-F238E27FC236}">
                <a16:creationId xmlns="" xmlns:a16="http://schemas.microsoft.com/office/drawing/2014/main" id="{8EA6D897-3AD8-DC3A-E9A6-D1938F70EE21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5233" y="2115128"/>
            <a:ext cx="4137067" cy="2371308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7E894101-1EA8-5823-49E8-B8E3C53C6362}"/>
              </a:ext>
            </a:extLst>
          </p:cNvPr>
          <p:cNvSpPr txBox="1"/>
          <p:nvPr/>
        </p:nvSpPr>
        <p:spPr>
          <a:xfrm>
            <a:off x="3192589" y="3419272"/>
            <a:ext cx="1228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n1_IP</a:t>
            </a:r>
          </a:p>
        </p:txBody>
      </p:sp>
      <p:sp>
        <p:nvSpPr>
          <p:cNvPr id="20" name="Right Bracket 19">
            <a:extLst>
              <a:ext uri="{FF2B5EF4-FFF2-40B4-BE49-F238E27FC236}">
                <a16:creationId xmlns="" xmlns:a16="http://schemas.microsoft.com/office/drawing/2014/main" id="{13E1AF79-C724-32CC-A97C-F39571F42B9E}"/>
              </a:ext>
            </a:extLst>
          </p:cNvPr>
          <p:cNvSpPr/>
          <p:nvPr/>
        </p:nvSpPr>
        <p:spPr>
          <a:xfrm rot="5400000">
            <a:off x="3620477" y="2932443"/>
            <a:ext cx="158777" cy="93480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="" xmlns:a16="http://schemas.microsoft.com/office/drawing/2014/main" id="{5FF888E7-3362-5C33-E73C-A75C6F8D380B}"/>
              </a:ext>
            </a:extLst>
          </p:cNvPr>
          <p:cNvSpPr txBox="1"/>
          <p:nvPr/>
        </p:nvSpPr>
        <p:spPr>
          <a:xfrm>
            <a:off x="7422309" y="2372461"/>
            <a:ext cx="1228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n1_IP</a:t>
            </a:r>
          </a:p>
        </p:txBody>
      </p:sp>
      <p:sp>
        <p:nvSpPr>
          <p:cNvPr id="22" name="Right Bracket 21">
            <a:extLst>
              <a:ext uri="{FF2B5EF4-FFF2-40B4-BE49-F238E27FC236}">
                <a16:creationId xmlns="" xmlns:a16="http://schemas.microsoft.com/office/drawing/2014/main" id="{707D805C-3D89-F2D0-5B22-99EB8DA29817}"/>
              </a:ext>
            </a:extLst>
          </p:cNvPr>
          <p:cNvSpPr/>
          <p:nvPr/>
        </p:nvSpPr>
        <p:spPr>
          <a:xfrm rot="16200000">
            <a:off x="7895171" y="2335337"/>
            <a:ext cx="158777" cy="93480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ight Bracket 22">
            <a:extLst>
              <a:ext uri="{FF2B5EF4-FFF2-40B4-BE49-F238E27FC236}">
                <a16:creationId xmlns="" xmlns:a16="http://schemas.microsoft.com/office/drawing/2014/main" id="{56BE5DC7-05B2-35C5-6C7E-FF27D232D364}"/>
              </a:ext>
            </a:extLst>
          </p:cNvPr>
          <p:cNvSpPr/>
          <p:nvPr/>
        </p:nvSpPr>
        <p:spPr>
          <a:xfrm rot="5400000">
            <a:off x="4702263" y="2919953"/>
            <a:ext cx="158777" cy="93480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="" xmlns:a16="http://schemas.microsoft.com/office/drawing/2014/main" id="{47AE6299-F82A-8BD8-B9B1-90709B952F7D}"/>
              </a:ext>
            </a:extLst>
          </p:cNvPr>
          <p:cNvSpPr txBox="1"/>
          <p:nvPr/>
        </p:nvSpPr>
        <p:spPr>
          <a:xfrm>
            <a:off x="4229406" y="3436762"/>
            <a:ext cx="1750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n1_INPUT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="" xmlns:a16="http://schemas.microsoft.com/office/drawing/2014/main" id="{A050C8BF-2165-1398-E621-44EA1210560A}"/>
              </a:ext>
            </a:extLst>
          </p:cNvPr>
          <p:cNvSpPr txBox="1"/>
          <p:nvPr/>
        </p:nvSpPr>
        <p:spPr>
          <a:xfrm>
            <a:off x="8444142" y="2359972"/>
            <a:ext cx="1750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n1_INPUT</a:t>
            </a:r>
          </a:p>
        </p:txBody>
      </p:sp>
      <p:sp>
        <p:nvSpPr>
          <p:cNvPr id="26" name="Right Bracket 25">
            <a:extLst>
              <a:ext uri="{FF2B5EF4-FFF2-40B4-BE49-F238E27FC236}">
                <a16:creationId xmlns="" xmlns:a16="http://schemas.microsoft.com/office/drawing/2014/main" id="{76F3BEAF-3976-9110-D6F9-4B5BAACD41C6}"/>
              </a:ext>
            </a:extLst>
          </p:cNvPr>
          <p:cNvSpPr/>
          <p:nvPr/>
        </p:nvSpPr>
        <p:spPr>
          <a:xfrm rot="16200000">
            <a:off x="8976962" y="2337837"/>
            <a:ext cx="158777" cy="93480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="" xmlns:a16="http://schemas.microsoft.com/office/drawing/2014/main" id="{D85DFFBE-4356-98CA-DEB2-F7A885C9211C}"/>
              </a:ext>
            </a:extLst>
          </p:cNvPr>
          <p:cNvSpPr txBox="1"/>
          <p:nvPr/>
        </p:nvSpPr>
        <p:spPr>
          <a:xfrm>
            <a:off x="10569790" y="2981098"/>
            <a:ext cx="774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n1</a:t>
            </a:r>
          </a:p>
        </p:txBody>
      </p:sp>
      <p:pic>
        <p:nvPicPr>
          <p:cNvPr id="29" name="Picture 28" descr="A close-up of a paper&#10;&#10;Description automatically generated">
            <a:extLst>
              <a:ext uri="{FF2B5EF4-FFF2-40B4-BE49-F238E27FC236}">
                <a16:creationId xmlns="" xmlns:a16="http://schemas.microsoft.com/office/drawing/2014/main" id="{1AE5E5A0-E070-9136-9B32-0B1CC504B129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7846" y="286324"/>
            <a:ext cx="4137067" cy="1838874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="" xmlns:a16="http://schemas.microsoft.com/office/drawing/2014/main" id="{8C46E35D-57F6-0DAA-8671-9137607B1687}"/>
              </a:ext>
            </a:extLst>
          </p:cNvPr>
          <p:cNvSpPr txBox="1"/>
          <p:nvPr/>
        </p:nvSpPr>
        <p:spPr>
          <a:xfrm>
            <a:off x="2172835" y="873448"/>
            <a:ext cx="1469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c13_IP</a:t>
            </a:r>
          </a:p>
        </p:txBody>
      </p:sp>
      <p:sp>
        <p:nvSpPr>
          <p:cNvPr id="31" name="Right Bracket 30">
            <a:extLst>
              <a:ext uri="{FF2B5EF4-FFF2-40B4-BE49-F238E27FC236}">
                <a16:creationId xmlns="" xmlns:a16="http://schemas.microsoft.com/office/drawing/2014/main" id="{629B1FE8-0B15-C818-2D13-0BD1F45EEC82}"/>
              </a:ext>
            </a:extLst>
          </p:cNvPr>
          <p:cNvSpPr/>
          <p:nvPr/>
        </p:nvSpPr>
        <p:spPr>
          <a:xfrm rot="5400000">
            <a:off x="2603646" y="296672"/>
            <a:ext cx="158777" cy="93480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ight Bracket 31">
            <a:extLst>
              <a:ext uri="{FF2B5EF4-FFF2-40B4-BE49-F238E27FC236}">
                <a16:creationId xmlns="" xmlns:a16="http://schemas.microsoft.com/office/drawing/2014/main" id="{8BBA47F4-C197-9D9B-9C6D-F3B9598A02B7}"/>
              </a:ext>
            </a:extLst>
          </p:cNvPr>
          <p:cNvSpPr/>
          <p:nvPr/>
        </p:nvSpPr>
        <p:spPr>
          <a:xfrm rot="5400000">
            <a:off x="8794579" y="206739"/>
            <a:ext cx="158777" cy="93480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="" xmlns:a16="http://schemas.microsoft.com/office/drawing/2014/main" id="{53DC876C-AED9-39A0-D35D-F72F56FE8C89}"/>
              </a:ext>
            </a:extLst>
          </p:cNvPr>
          <p:cNvSpPr txBox="1"/>
          <p:nvPr/>
        </p:nvSpPr>
        <p:spPr>
          <a:xfrm>
            <a:off x="8349517" y="786008"/>
            <a:ext cx="16189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c13_IP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="" xmlns:a16="http://schemas.microsoft.com/office/drawing/2014/main" id="{C8AA7F9F-BCDB-516B-65E9-D0D1C0D3494D}"/>
              </a:ext>
            </a:extLst>
          </p:cNvPr>
          <p:cNvSpPr txBox="1"/>
          <p:nvPr/>
        </p:nvSpPr>
        <p:spPr>
          <a:xfrm>
            <a:off x="10572289" y="735076"/>
            <a:ext cx="10176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c13</a:t>
            </a:r>
          </a:p>
        </p:txBody>
      </p:sp>
      <p:sp>
        <p:nvSpPr>
          <p:cNvPr id="35" name="Right Bracket 34">
            <a:extLst>
              <a:ext uri="{FF2B5EF4-FFF2-40B4-BE49-F238E27FC236}">
                <a16:creationId xmlns="" xmlns:a16="http://schemas.microsoft.com/office/drawing/2014/main" id="{FB41C98E-22DC-0879-E7ED-57B0DF9F771F}"/>
              </a:ext>
            </a:extLst>
          </p:cNvPr>
          <p:cNvSpPr/>
          <p:nvPr/>
        </p:nvSpPr>
        <p:spPr>
          <a:xfrm rot="5400000">
            <a:off x="3678144" y="5778276"/>
            <a:ext cx="150874" cy="86235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ight Bracket 35">
            <a:extLst>
              <a:ext uri="{FF2B5EF4-FFF2-40B4-BE49-F238E27FC236}">
                <a16:creationId xmlns="" xmlns:a16="http://schemas.microsoft.com/office/drawing/2014/main" id="{45000264-2C28-9B51-3CD1-72F9E894A05C}"/>
              </a:ext>
            </a:extLst>
          </p:cNvPr>
          <p:cNvSpPr/>
          <p:nvPr/>
        </p:nvSpPr>
        <p:spPr>
          <a:xfrm rot="5400000">
            <a:off x="9092090" y="5825746"/>
            <a:ext cx="150874" cy="862350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65C35BD8-DC4B-A35E-990F-85D0474F7A22}"/>
              </a:ext>
            </a:extLst>
          </p:cNvPr>
          <p:cNvSpPr txBox="1"/>
          <p:nvPr/>
        </p:nvSpPr>
        <p:spPr>
          <a:xfrm>
            <a:off x="2923081" y="6287398"/>
            <a:ext cx="19048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c13_INPU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7A3C6AE0-D0CC-A868-9409-6BB30DBCB44E}"/>
              </a:ext>
            </a:extLst>
          </p:cNvPr>
          <p:cNvSpPr txBox="1"/>
          <p:nvPr/>
        </p:nvSpPr>
        <p:spPr>
          <a:xfrm>
            <a:off x="8441961" y="6349858"/>
            <a:ext cx="19048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c13_INPUT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586A3EF8-071E-64A6-1BE6-FDB05797B098}"/>
              </a:ext>
            </a:extLst>
          </p:cNvPr>
          <p:cNvSpPr txBox="1"/>
          <p:nvPr/>
        </p:nvSpPr>
        <p:spPr>
          <a:xfrm>
            <a:off x="10531649" y="5968877"/>
            <a:ext cx="10176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c13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89138D47-DD13-6ADC-1CE9-A31E743B97D8}"/>
              </a:ext>
            </a:extLst>
          </p:cNvPr>
          <p:cNvSpPr txBox="1"/>
          <p:nvPr/>
        </p:nvSpPr>
        <p:spPr>
          <a:xfrm>
            <a:off x="3329577" y="-83422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9870B0BB-DAD3-3D27-E0B8-EB3783FD51AE}"/>
              </a:ext>
            </a:extLst>
          </p:cNvPr>
          <p:cNvSpPr txBox="1"/>
          <p:nvPr/>
        </p:nvSpPr>
        <p:spPr>
          <a:xfrm>
            <a:off x="8278833" y="-35952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g1-∆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="" xmlns:a16="http://schemas.microsoft.com/office/drawing/2014/main" id="{056DC215-AEC0-F249-4FED-0EC490F80DCE}"/>
              </a:ext>
            </a:extLst>
          </p:cNvPr>
          <p:cNvSpPr txBox="1"/>
          <p:nvPr/>
        </p:nvSpPr>
        <p:spPr>
          <a:xfrm>
            <a:off x="-172125" y="-3"/>
            <a:ext cx="30228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5E _Sourc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</a:p>
          <a:p>
            <a:pPr algn="ctr"/>
            <a:r>
              <a:rPr lang="en-US" b="1" smtClean="0">
                <a:latin typeface="Arial" panose="020B0604020202020204" pitchFamily="34" charset="0"/>
                <a:cs typeface="Arial" panose="020B0604020202020204" pitchFamily="34" charset="0"/>
              </a:rPr>
              <a:t>Annotated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88794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el Aviv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K19</dc:creator>
  <cp:lastModifiedBy>MartinK19</cp:lastModifiedBy>
  <cp:revision>1</cp:revision>
  <dcterms:created xsi:type="dcterms:W3CDTF">2023-07-12T11:29:34Z</dcterms:created>
  <dcterms:modified xsi:type="dcterms:W3CDTF">2023-07-12T11:30:05Z</dcterms:modified>
</cp:coreProperties>
</file>